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81F5C0-DC7F-4C49-B85C-4787CEC560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8F93E-BBDA-44A5-8537-35A98084EC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49D0A6-33F5-4BF0-9670-C2B229919E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C1405A-7863-49D6-9028-33CE5280A65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9CEEC-1F6C-483B-83E7-665B422568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2AE425-EFD0-4C8F-98CE-806B4D61FF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E8FE62-1262-4C1C-8DD2-1741C0D693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6769D3-A344-4C52-BC02-DF6BB0343C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0D3E8-132B-48B6-A84D-08AE2062D1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E75DF3-B96D-4E75-BA68-494074086D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3267C-9624-49F0-801A-F0A7308175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DF4ED-1136-4932-85FF-726C092DA3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07533A-9B4B-4170-8653-5526B06BBE0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ersonalization, niche association, and reference genome coverage in strain-level metagenomic profil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1371600" y="1244520"/>
            <a:ext cx="6400800" cy="43992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J Lloyd-Price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1–6 (2017) doi:10.1038/nature2388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16T09:00:34Z</dcterms:created>
  <dc:creator>ravikumar.n</dc:creator>
  <dc:description/>
  <dc:language>en-US</dc:language>
  <cp:lastModifiedBy>ravikumar.n</cp:lastModifiedBy>
  <dcterms:modified xsi:type="dcterms:W3CDTF">2017-09-16T09:00:41Z</dcterms:modified>
  <cp:revision>1</cp:revision>
  <dc:subject/>
  <dc:title>Personalization, niche association, and reference genome coverage in strain-level metagenomic profiles</dc:title>
</cp:coreProperties>
</file>